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83" r:id="rId3"/>
    <p:sldId id="284" r:id="rId4"/>
    <p:sldId id="285" r:id="rId5"/>
    <p:sldId id="286" r:id="rId6"/>
    <p:sldId id="287" r:id="rId7"/>
    <p:sldId id="288" r:id="rId8"/>
    <p:sldId id="30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14"/>
  </p:normalViewPr>
  <p:slideViewPr>
    <p:cSldViewPr snapToGrid="0" snapToObjects="1">
      <p:cViewPr varScale="1">
        <p:scale>
          <a:sx n="112" d="100"/>
          <a:sy n="112" d="100"/>
        </p:scale>
        <p:origin x="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0A8EC-C521-2141-A569-405AAA6828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893FA7B-36F2-B845-985B-6DFB5E35D2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B31968-2895-9048-B2F3-4CBCBF1A5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547899-8672-4B4B-A0DC-179FE8715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37114F-45E4-404D-8A10-926E678AA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70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7EA522-9937-C346-80DF-3A28B29F8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58945F-7849-CF42-AF3D-E2C4C5EA71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BF655A-93D6-A043-8A74-BB789810A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D15CBC-3EF8-4441-9F5A-74D363A09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4C6A9A-723B-D44D-A073-C0249D30F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574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F32A06-53B4-C24B-AC06-6AB131421E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471D20-4B98-2349-B5C5-527545A3FE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BF96B0-6B22-0C46-8DB8-333FE4BC1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14D602-61F5-1C43-AE02-70E2CE875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F69FF4-D710-444A-AEFF-409CB2552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77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A0245-CCA8-4646-8820-6AA02C0762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7DA4A9-AD73-CB48-B494-B8B16EBE7F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D2393F-7EDB-6D4F-B939-FDA9ADA4D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48D9C8-B8BE-5343-B193-0AE317E74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A20E5-2BC9-C946-B350-76B3D2302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610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A6BAE-7E8E-DE47-94F6-4F7FAFE08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68C8FE-77FF-5D4F-A8BE-B75E3F0F11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7C6310-EB85-F442-A954-221BF5228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E2457-6A92-804C-92AF-BA8E2ADDE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A1F33-3C31-0A44-B613-A82748B923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3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C7563-C41D-134A-8697-5DAA70EC5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C73E40-3FA8-9842-8F6B-6B975BC3EF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082486-EFEE-1E47-9A31-7085DB5622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D7B61A-8EE4-CF49-ADA6-1C6E488F3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16D4E4-CE79-A04C-B50A-747E210C7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08ACF9-A4A5-B443-84DF-AC2789B7F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76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9F743-DBA9-0B43-B74B-B1331C7D7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0DE7B5-6596-3D4C-B290-9364E55C3A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F649B9-AA0C-014F-AA4C-AABA65043F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D26DF8-D47C-324A-A60B-0C8739C03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83D41C-81B3-F946-AA00-807107FB04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154F0D-CBE9-9242-8EC7-363D09E9D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59ACBF-A9D1-544C-9391-44F5D32CB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875B466-59BC-784E-8393-E208C42F7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74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678DF-9834-0A47-9933-F0FE218A16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B40AF1-032C-A24C-99BE-2997C0BBF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86A997-3999-634A-AA85-96506D2C4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EC8223-1F6E-4F45-9E1B-32D49F13D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61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8BD92C-F0EF-C943-B828-F89976D61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D0568D-6B1D-D844-B04F-EAC34D715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1B5E3C2-8569-1949-A08D-6A3CDE1C3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263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A2E4AC-8D0C-B341-8571-5ADC560A8E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D7AAA3-A459-AF4A-AC2F-5B9DB20978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D91CCA-6D46-5E4A-AD5C-9636AF5584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0E83FC-9141-6E46-89D3-82548CA44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186F36-4358-8F45-8C8E-EB81A1D9E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FCCF3E-C308-9C45-83EB-07DF9571F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310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A7975-6345-C142-BBBB-A9C8E57004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6907DA-A259-EC46-BB59-8F69CA2478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85C129-5980-9F42-9D91-BE3093CFFF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E03DE6-5E0F-EB41-84A0-A009E6C9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09B049-314C-734D-B41D-A0D5451C9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5D9160-C6D9-7344-8DA5-7EAB884BE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874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DA8CE8-7970-1048-8180-B7544F6CD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EE281E-3D79-834E-A870-840C3EFC2D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1E670-D871-F24D-BE63-E6B47D084B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15067-4886-B540-8A19-F473DC609942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DD740-36E3-6F41-8BE5-AC70CA88C3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1EC44E-8A01-AA45-A42A-53748A78F0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6D9EF-521D-B747-942E-D333234D6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48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235200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Resuscitation Leadership Training  </a:t>
            </a:r>
            <a:br>
              <a:rPr lang="en-US" dirty="0"/>
            </a:br>
            <a:br>
              <a:rPr lang="en-US" dirty="0"/>
            </a:br>
            <a:r>
              <a:rPr lang="en-US" sz="4400" dirty="0"/>
              <a:t>Simulation Case: Missed Dialysi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02238"/>
            <a:ext cx="9144000" cy="1655762"/>
          </a:xfrm>
        </p:spPr>
        <p:txBody>
          <a:bodyPr/>
          <a:lstStyle/>
          <a:p>
            <a:r>
              <a:rPr lang="en-US" dirty="0"/>
              <a:t>All Material Author Own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441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8" b="4675"/>
          <a:stretch/>
        </p:blipFill>
        <p:spPr>
          <a:xfrm>
            <a:off x="2647951" y="2214564"/>
            <a:ext cx="5531827" cy="3857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0196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- Lung</a:t>
            </a:r>
          </a:p>
        </p:txBody>
      </p:sp>
      <p:pic>
        <p:nvPicPr>
          <p:cNvPr id="4" name="703727_20131011_cardio_0007_dvd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032000" y="1930400"/>
            <a:ext cx="6901586" cy="364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8684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POCUS </a:t>
            </a:r>
            <a:r>
              <a:rPr lang="en-US" dirty="0"/>
              <a:t>- Echo</a:t>
            </a:r>
          </a:p>
        </p:txBody>
      </p:sp>
      <p:pic>
        <p:nvPicPr>
          <p:cNvPr id="4" name="Normal EF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509010" y="1413119"/>
            <a:ext cx="6773008" cy="5079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7364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1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oday’s EKG</a:t>
            </a:r>
          </a:p>
        </p:txBody>
      </p:sp>
      <p:pic>
        <p:nvPicPr>
          <p:cNvPr id="4" name="Picture 3" descr="hyperkalemia 8.5 very tented.jp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9740" y="1891614"/>
            <a:ext cx="8417186" cy="3150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75405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ld EKG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0" y="1524000"/>
            <a:ext cx="8128000" cy="381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85153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BG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770415" y="1417639"/>
            <a:ext cx="6041571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ood gas values</a:t>
            </a:r>
          </a:p>
          <a:p>
            <a:r>
              <a:rPr lang="en-US" b="1" i="1" dirty="0"/>
              <a:t>	pH			7.25</a:t>
            </a:r>
            <a:endParaRPr lang="en-US" dirty="0"/>
          </a:p>
          <a:p>
            <a:r>
              <a:rPr lang="en-US" b="1" i="1" dirty="0"/>
              <a:t>	pCO2			35	mmHg</a:t>
            </a:r>
            <a:endParaRPr lang="en-US" dirty="0"/>
          </a:p>
          <a:p>
            <a:r>
              <a:rPr lang="en-US" dirty="0"/>
              <a:t>	pO2			12	mmHg</a:t>
            </a:r>
          </a:p>
          <a:p>
            <a:r>
              <a:rPr lang="en-US" dirty="0"/>
              <a:t>Oximetry values</a:t>
            </a:r>
          </a:p>
          <a:p>
            <a:r>
              <a:rPr lang="en-US" dirty="0"/>
              <a:t>	</a:t>
            </a:r>
            <a:r>
              <a:rPr lang="en-US" b="1" i="1" dirty="0" err="1"/>
              <a:t>ctHb</a:t>
            </a:r>
            <a:r>
              <a:rPr lang="en-US" b="1" i="1" dirty="0"/>
              <a:t>			12	g/</a:t>
            </a:r>
            <a:r>
              <a:rPr lang="en-US" b="1" i="1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err="1"/>
              <a:t>Hctc</a:t>
            </a:r>
            <a:r>
              <a:rPr lang="en-US" dirty="0"/>
              <a:t>			36	%</a:t>
            </a:r>
          </a:p>
          <a:p>
            <a:r>
              <a:rPr lang="en-US" dirty="0"/>
              <a:t>	sO2			17.6	%</a:t>
            </a:r>
          </a:p>
          <a:p>
            <a:r>
              <a:rPr lang="en-US" dirty="0"/>
              <a:t>	</a:t>
            </a:r>
            <a:r>
              <a:rPr lang="en-US" dirty="0" err="1"/>
              <a:t>FMetHb</a:t>
            </a:r>
            <a:r>
              <a:rPr lang="en-US" dirty="0"/>
              <a:t>		0.1	%</a:t>
            </a:r>
          </a:p>
          <a:p>
            <a:r>
              <a:rPr lang="en-US" dirty="0"/>
              <a:t>Electrolyte values</a:t>
            </a:r>
          </a:p>
          <a:p>
            <a:r>
              <a:rPr lang="en-US" dirty="0"/>
              <a:t>	Na			139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l			98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a			1.06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Metabolite values</a:t>
            </a:r>
          </a:p>
          <a:p>
            <a:r>
              <a:rPr lang="en-US" dirty="0"/>
              <a:t>	</a:t>
            </a:r>
            <a:r>
              <a:rPr lang="en-US" dirty="0" err="1"/>
              <a:t>Gluc</a:t>
            </a:r>
            <a:r>
              <a:rPr lang="en-US" dirty="0"/>
              <a:t>			110	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b="1" i="1" dirty="0"/>
              <a:t>Lac			4.5	</a:t>
            </a:r>
            <a:r>
              <a:rPr lang="en-US" b="1" i="1" dirty="0" err="1"/>
              <a:t>mmol</a:t>
            </a:r>
            <a:r>
              <a:rPr lang="en-US" b="1" i="1" dirty="0"/>
              <a:t>/L</a:t>
            </a:r>
            <a:endParaRPr lang="en-US" dirty="0"/>
          </a:p>
          <a:p>
            <a:r>
              <a:rPr lang="en-US" dirty="0"/>
              <a:t>Acid-base status</a:t>
            </a:r>
          </a:p>
          <a:p>
            <a:r>
              <a:rPr lang="en-US" dirty="0"/>
              <a:t>	</a:t>
            </a:r>
            <a:r>
              <a:rPr lang="en-US" b="1" i="1" dirty="0"/>
              <a:t>cHCO3			15	</a:t>
            </a:r>
            <a:r>
              <a:rPr lang="en-US" b="1" i="1" dirty="0" err="1"/>
              <a:t>mmol</a:t>
            </a:r>
            <a:r>
              <a:rPr lang="en-US" b="1" i="1" dirty="0"/>
              <a:t>/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17682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294DEA-E9AE-C641-81BF-4786AC898F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st-arrest EKG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2965723-6BE0-4A4F-8229-3A7AD07C4A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4550" y="1914525"/>
            <a:ext cx="76200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82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4</Words>
  <Application>Microsoft Macintosh PowerPoint</Application>
  <PresentationFormat>Widescreen</PresentationFormat>
  <Paragraphs>27</Paragraphs>
  <Slides>8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Resuscitation Leadership Training    Simulation Case: Missed Dialysis</vt:lpstr>
      <vt:lpstr>CXR</vt:lpstr>
      <vt:lpstr>POCUS - Lung</vt:lpstr>
      <vt:lpstr>POCUS - Echo</vt:lpstr>
      <vt:lpstr>Today’s EKG</vt:lpstr>
      <vt:lpstr>Old EKG</vt:lpstr>
      <vt:lpstr>VBG</vt:lpstr>
      <vt:lpstr>Post-arrest EK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scitation Leadership Training    Simulation Case: Missed Dialysis</dc:title>
  <dc:creator>Microsoft Office User</dc:creator>
  <cp:lastModifiedBy>Microsoft Office User</cp:lastModifiedBy>
  <cp:revision>2</cp:revision>
  <dcterms:created xsi:type="dcterms:W3CDTF">2022-02-26T18:27:12Z</dcterms:created>
  <dcterms:modified xsi:type="dcterms:W3CDTF">2022-02-26T19:14:01Z</dcterms:modified>
</cp:coreProperties>
</file>